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358" r:id="rId2"/>
    <p:sldId id="363" r:id="rId3"/>
    <p:sldId id="335" r:id="rId4"/>
    <p:sldId id="336" r:id="rId5"/>
    <p:sldId id="360" r:id="rId6"/>
    <p:sldId id="359" r:id="rId7"/>
    <p:sldId id="361" r:id="rId8"/>
    <p:sldId id="337" r:id="rId9"/>
    <p:sldId id="362" r:id="rId10"/>
    <p:sldId id="357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367"/>
    <p:restoredTop sz="95833"/>
  </p:normalViewPr>
  <p:slideViewPr>
    <p:cSldViewPr snapToGrid="0" snapToObjects="1">
      <p:cViewPr varScale="1">
        <p:scale>
          <a:sx n="102" d="100"/>
          <a:sy n="102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D92BF9-B4D1-254E-A154-54900B4B192B}" type="datetimeFigureOut">
              <a:rPr lang="en-US" smtClean="0"/>
              <a:t>6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ED5760-B257-7E44-B370-91C0063DDB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8486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9DB5B-D688-AA4D-881E-49A5C7A367A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779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2A951B-5AAA-EA49-BA47-9DDB1BD885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E4564-78D7-7F40-A01A-1D6C1076B2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BB713-CF10-9D4D-A246-4090CDAE6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030A5F-287F-7E4E-BDB8-90FF871A5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1C7EC4-1587-694A-AB2B-D09C20F2B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551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84A9D-6061-1346-97DC-98B17302D2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ADB1B4-A8F8-4640-A9D0-15134984A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E81168-8C5A-C54B-B872-A808000B3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69350E-A849-7B44-90C9-509221110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49F8F-E0F3-9443-BD24-48B4DA19D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03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9E820D-8C9C-BE44-85FF-781115B0D2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92A086-A3C6-9845-8314-03F458E4CA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83CC94-B050-654C-A03C-D8F3961D5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2DDDA0-4058-2240-9413-36C93D8BD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A5B823-F9F7-314D-8ADA-CA1308717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952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7248A-59D4-6441-8FA6-0ED0D4E11A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DF2844-5150-8646-A409-E7BA2698A9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95302A-E9FA-A44B-83CA-F9B5AB95B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B0CD4E-A70C-004A-9445-8AC6665E7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31D1F5-A30E-234E-AD63-7199472CF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984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8CDE19-CF4A-5348-A829-505315E0E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CB3806-1D31-D849-918D-E926F5A0D1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D86546-E9EB-7044-861B-928E4FCC5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5D4FE1-4394-BC48-B0A3-895CC79EB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9B65C3-D5CC-BD45-A68B-1387A50BE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791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4962D-0A43-1441-A466-DE22CFC8B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44C5A7-92FC-E545-BC87-AEF4C7593B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7DD999-8E32-B845-901B-8F592B4177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737703-A57C-BA44-8A14-44A5488E8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A27D4C-33E6-CB4A-B8E7-61AA771A8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93B5E3-3A78-264E-A909-4DAB21B02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400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C4FEA-2D24-DF47-AB28-72DA2F4B8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49E482-4B0E-EF4D-8D03-7370223202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FC2317-0348-5E48-B147-A9E4DA759C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59EDA0-8620-5541-8519-D902DFDF14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D9BB219-7DEF-BF4C-8307-4A53E827D2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58D108-5BCE-3B4A-9CA1-2CB934AC6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C1EDDB-1283-F144-95F3-5AAE30FE1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0D2428-A947-A446-8B7B-99B0CFFC1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348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8537D-855F-A64E-934C-554D4AB4B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2B7554-458C-8D48-8649-2DE63AAB7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5A984C-249B-B34F-903B-B9897F72B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499CFD-06EF-D643-A617-CC943633D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98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AA5096-CD73-1748-A47F-F4CF339AC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8ED045-1C42-1F47-9BAE-0DB12F667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D3122E-C5AC-FF4D-B8CE-30F0DC59D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61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4A21A-AB70-8A40-B9C3-8DE7717C5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C441B8-5D60-F84E-9F85-49FF309874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BFF269-EC99-F44D-A46E-D5633AAE75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3A4BC3-260F-0746-873D-FD61C944D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EC02FF-B7FB-604B-AF7E-A061AD292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511905-C591-E542-9F59-AD5584D64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512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0AF4A-704C-5243-B48E-35134B82D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E6E355-B2FF-0742-894D-864B75BE43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4BC550-932D-2348-9D84-877815167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A80E29-329B-BD44-8BD3-333213E1C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F77978-4924-2A4F-B13B-4EDB40AB2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5450D7-186C-BB4A-97A0-8623A11A8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550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FAE3AB-CD28-1349-B671-CA21FB97EF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34A0B-FE24-1343-BB44-71F2241B9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48FFD-9D83-8844-8C0E-5B2160193A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32FD2-7DC0-1B43-8663-D1A21B92083A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C70FF4-FD9C-9E47-ACC8-11A482FC3C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CDC219-BC99-5A45-9573-572DD13539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0101F4-C156-7D4C-875B-0189768C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51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emf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7" Type="http://schemas.openxmlformats.org/officeDocument/2006/relationships/image" Target="../media/image32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7" Type="http://schemas.openxmlformats.org/officeDocument/2006/relationships/image" Target="../media/image38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emf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7" Type="http://schemas.openxmlformats.org/officeDocument/2006/relationships/image" Target="../media/image44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emf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7" Type="http://schemas.openxmlformats.org/officeDocument/2006/relationships/image" Target="../media/image50.emf"/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emf"/><Relationship Id="rId5" Type="http://schemas.openxmlformats.org/officeDocument/2006/relationships/image" Target="../media/image48.emf"/><Relationship Id="rId4" Type="http://schemas.openxmlformats.org/officeDocument/2006/relationships/image" Target="../media/image4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sitting, drawing&#10;&#10;Description automatically generated">
            <a:extLst>
              <a:ext uri="{FF2B5EF4-FFF2-40B4-BE49-F238E27FC236}">
                <a16:creationId xmlns:a16="http://schemas.microsoft.com/office/drawing/2014/main" id="{FF462F83-3231-8F47-811A-4AA3D020B3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104"/>
          <a:stretch/>
        </p:blipFill>
        <p:spPr>
          <a:xfrm>
            <a:off x="3208148" y="704097"/>
            <a:ext cx="6035040" cy="3221463"/>
          </a:xfrm>
          <a:prstGeom prst="rect">
            <a:avLst/>
          </a:prstGeom>
        </p:spPr>
      </p:pic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1369C96E-AAD6-9A47-8038-17558E2267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14793" y="4299703"/>
            <a:ext cx="5943600" cy="18542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D37FC3A-87D0-DB46-9D6C-123E371E241D}"/>
              </a:ext>
            </a:extLst>
          </p:cNvPr>
          <p:cNvSpPr txBox="1"/>
          <p:nvPr/>
        </p:nvSpPr>
        <p:spPr>
          <a:xfrm>
            <a:off x="263472" y="20860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1457A7-3B0D-FB4F-91AA-851F7D004970}"/>
              </a:ext>
            </a:extLst>
          </p:cNvPr>
          <p:cNvSpPr txBox="1"/>
          <p:nvPr/>
        </p:nvSpPr>
        <p:spPr>
          <a:xfrm>
            <a:off x="2948812" y="704097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CB92A6-3881-724B-B203-2AEE2D2E2604}"/>
              </a:ext>
            </a:extLst>
          </p:cNvPr>
          <p:cNvSpPr txBox="1"/>
          <p:nvPr/>
        </p:nvSpPr>
        <p:spPr>
          <a:xfrm>
            <a:off x="2974751" y="3740894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8777186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9EC10F2-C97F-C247-9B7F-D16864377F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3158"/>
          <a:stretch/>
        </p:blipFill>
        <p:spPr>
          <a:xfrm>
            <a:off x="7793914" y="601620"/>
            <a:ext cx="3017520" cy="277610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D828329-C8EF-F744-BFB9-2B392910F92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2393"/>
          <a:stretch/>
        </p:blipFill>
        <p:spPr>
          <a:xfrm>
            <a:off x="1774150" y="3183661"/>
            <a:ext cx="3044106" cy="277610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245FBBA-F22B-2946-843B-6C83ACBD99B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3696"/>
          <a:stretch/>
        </p:blipFill>
        <p:spPr>
          <a:xfrm>
            <a:off x="4801649" y="3183661"/>
            <a:ext cx="2998805" cy="277610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7F3D40A-2836-5243-9266-2B307864D10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3158"/>
          <a:stretch/>
        </p:blipFill>
        <p:spPr>
          <a:xfrm>
            <a:off x="7793914" y="3184823"/>
            <a:ext cx="3017520" cy="277610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62942D2-114B-3442-BC35-1570271020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6987" t="32524" r="-3591" b="48821"/>
          <a:stretch/>
        </p:blipFill>
        <p:spPr>
          <a:xfrm>
            <a:off x="10199162" y="5859039"/>
            <a:ext cx="576950" cy="51788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510773A-DC2F-9A43-9A4B-0DF53FC5FD32}"/>
              </a:ext>
            </a:extLst>
          </p:cNvPr>
          <p:cNvSpPr txBox="1"/>
          <p:nvPr/>
        </p:nvSpPr>
        <p:spPr>
          <a:xfrm>
            <a:off x="2075798" y="5117725"/>
            <a:ext cx="12218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= non responder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 = respond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028374-779D-EC4E-BD8C-3A16F1866287}"/>
              </a:ext>
            </a:extLst>
          </p:cNvPr>
          <p:cNvSpPr txBox="1"/>
          <p:nvPr/>
        </p:nvSpPr>
        <p:spPr>
          <a:xfrm>
            <a:off x="8052035" y="2627655"/>
            <a:ext cx="8563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 = females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 = mal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94E82F-D71A-EB4C-87A8-91F2844B1125}"/>
              </a:ext>
            </a:extLst>
          </p:cNvPr>
          <p:cNvSpPr txBox="1"/>
          <p:nvPr/>
        </p:nvSpPr>
        <p:spPr>
          <a:xfrm>
            <a:off x="8072989" y="866291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8D81C1-FB4C-A34D-9AE7-9E8CF55679AF}"/>
              </a:ext>
            </a:extLst>
          </p:cNvPr>
          <p:cNvSpPr txBox="1"/>
          <p:nvPr/>
        </p:nvSpPr>
        <p:spPr>
          <a:xfrm>
            <a:off x="2057846" y="3410647"/>
            <a:ext cx="15295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INICAL RESPONS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F650447-8FF0-D842-B122-63F605B51AAE}"/>
              </a:ext>
            </a:extLst>
          </p:cNvPr>
          <p:cNvSpPr txBox="1"/>
          <p:nvPr/>
        </p:nvSpPr>
        <p:spPr>
          <a:xfrm>
            <a:off x="5086048" y="3432433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COHOL CONSUMP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F3E29B8-5851-D441-B63E-E55894719C92}"/>
              </a:ext>
            </a:extLst>
          </p:cNvPr>
          <p:cNvSpPr txBox="1"/>
          <p:nvPr/>
        </p:nvSpPr>
        <p:spPr>
          <a:xfrm>
            <a:off x="8084222" y="3432433"/>
            <a:ext cx="7970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MOKING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047FDDA-3F6C-C845-ABF8-9069D186456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2743"/>
          <a:stretch/>
        </p:blipFill>
        <p:spPr>
          <a:xfrm>
            <a:off x="1669665" y="577938"/>
            <a:ext cx="3017520" cy="276748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A05AB65-E901-2F42-A43D-79DEAC58B72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12743"/>
          <a:stretch/>
        </p:blipFill>
        <p:spPr>
          <a:xfrm>
            <a:off x="4647788" y="594867"/>
            <a:ext cx="3017520" cy="276290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09312C8-D64E-5E40-A0A6-700A01CC04D0}"/>
              </a:ext>
            </a:extLst>
          </p:cNvPr>
          <p:cNvSpPr txBox="1"/>
          <p:nvPr/>
        </p:nvSpPr>
        <p:spPr>
          <a:xfrm>
            <a:off x="2013060" y="842435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AC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8D56E7-4D9A-1349-A41E-E0DF272F6A01}"/>
              </a:ext>
            </a:extLst>
          </p:cNvPr>
          <p:cNvSpPr txBox="1"/>
          <p:nvPr/>
        </p:nvSpPr>
        <p:spPr>
          <a:xfrm>
            <a:off x="4972935" y="842477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THNICITY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454ABC3-65E6-564D-A368-638BE009C72E}"/>
              </a:ext>
            </a:extLst>
          </p:cNvPr>
          <p:cNvSpPr txBox="1"/>
          <p:nvPr/>
        </p:nvSpPr>
        <p:spPr>
          <a:xfrm>
            <a:off x="263472" y="20860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750598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1872460" y="109802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040587" y="100061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MI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2A28CDAB-F4AD-3043-973E-44F706F4186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50" t="6688" r="9993" b="1610"/>
          <a:stretch/>
        </p:blipFill>
        <p:spPr>
          <a:xfrm>
            <a:off x="8467099" y="260876"/>
            <a:ext cx="3657600" cy="298370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957C83F-EAFB-D745-A08F-8DE6DE6F37E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053" t="9370" r="11682" b="2503"/>
          <a:stretch/>
        </p:blipFill>
        <p:spPr>
          <a:xfrm>
            <a:off x="4211969" y="277879"/>
            <a:ext cx="3657600" cy="2928397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46D8AC91-3E07-DD44-B7F4-EBC7003C5BA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682" t="6711" r="37974" b="29753"/>
          <a:stretch/>
        </p:blipFill>
        <p:spPr>
          <a:xfrm>
            <a:off x="1005841" y="306238"/>
            <a:ext cx="2743200" cy="265038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CA5EEB1E-B6D1-D940-9F60-50D1ABC2639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405" t="5926" r="22781" b="7299"/>
          <a:stretch/>
        </p:blipFill>
        <p:spPr>
          <a:xfrm>
            <a:off x="1005841" y="3523776"/>
            <a:ext cx="2651760" cy="255991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80C117A-642E-764E-B829-F2098C83D2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0926" r="11682"/>
          <a:stretch/>
        </p:blipFill>
        <p:spPr>
          <a:xfrm>
            <a:off x="4120529" y="3523776"/>
            <a:ext cx="3749040" cy="2894626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BEE65989-89FD-AA4B-AF06-FC28805EE49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287" t="7299" r="11683" b="3162"/>
          <a:stretch/>
        </p:blipFill>
        <p:spPr>
          <a:xfrm>
            <a:off x="8467099" y="3375139"/>
            <a:ext cx="3657600" cy="2948487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4FF0485E-515C-A74D-8FD5-580F775054E4}"/>
              </a:ext>
            </a:extLst>
          </p:cNvPr>
          <p:cNvSpPr/>
          <p:nvPr/>
        </p:nvSpPr>
        <p:spPr>
          <a:xfrm>
            <a:off x="10785528" y="3079029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02.5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8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FD1D282-86D4-4540-BFEC-DA0EC1E21BD7}"/>
              </a:ext>
            </a:extLst>
          </p:cNvPr>
          <p:cNvSpPr/>
          <p:nvPr/>
        </p:nvSpPr>
        <p:spPr>
          <a:xfrm>
            <a:off x="6687640" y="3103392"/>
            <a:ext cx="109517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59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5.5E-7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BB30FAD-6621-5E44-AFDD-3C3E481358AC}"/>
              </a:ext>
            </a:extLst>
          </p:cNvPr>
          <p:cNvSpPr/>
          <p:nvPr/>
        </p:nvSpPr>
        <p:spPr>
          <a:xfrm>
            <a:off x="2420136" y="3013751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25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01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1A7BC57-B585-8647-A9EA-7E687667D9DC}"/>
              </a:ext>
            </a:extLst>
          </p:cNvPr>
          <p:cNvSpPr/>
          <p:nvPr/>
        </p:nvSpPr>
        <p:spPr>
          <a:xfrm>
            <a:off x="2415003" y="6247463"/>
            <a:ext cx="109517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38.3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3.3E-7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B0B7B3EF-4F38-784B-8BE1-3C7229772428}"/>
              </a:ext>
            </a:extLst>
          </p:cNvPr>
          <p:cNvSpPr/>
          <p:nvPr/>
        </p:nvSpPr>
        <p:spPr>
          <a:xfrm>
            <a:off x="6674816" y="6256506"/>
            <a:ext cx="122341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00.2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8.2E-14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FAE081F5-1A7E-8943-A931-88B3DD64C4BC}"/>
              </a:ext>
            </a:extLst>
          </p:cNvPr>
          <p:cNvSpPr/>
          <p:nvPr/>
        </p:nvSpPr>
        <p:spPr>
          <a:xfrm>
            <a:off x="10810584" y="6302986"/>
            <a:ext cx="11592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71.6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2.7E-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9847436-463C-B045-94A1-534B08B81915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4264714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2218231" y="43392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496903" y="43392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MI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38A243A-613D-B34E-AD70-BF3116E3D0EC}"/>
              </a:ext>
            </a:extLst>
          </p:cNvPr>
          <p:cNvSpPr/>
          <p:nvPr/>
        </p:nvSpPr>
        <p:spPr>
          <a:xfrm>
            <a:off x="3116533" y="3357139"/>
            <a:ext cx="109837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23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sz="900" dirty="0"/>
              <a:t> 0.000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0941FC0-A98B-2847-BBC5-2562371A6F93}"/>
              </a:ext>
            </a:extLst>
          </p:cNvPr>
          <p:cNvSpPr/>
          <p:nvPr/>
        </p:nvSpPr>
        <p:spPr>
          <a:xfrm>
            <a:off x="6396949" y="3357139"/>
            <a:ext cx="107593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 34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3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0E3F26B9-B9A1-C646-A8B6-AE9722954932}"/>
              </a:ext>
            </a:extLst>
          </p:cNvPr>
          <p:cNvSpPr/>
          <p:nvPr/>
        </p:nvSpPr>
        <p:spPr>
          <a:xfrm>
            <a:off x="10618658" y="3353479"/>
            <a:ext cx="117211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20.3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02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4436634-1703-3044-B07D-B18C8883034B}"/>
              </a:ext>
            </a:extLst>
          </p:cNvPr>
          <p:cNvSpPr/>
          <p:nvPr/>
        </p:nvSpPr>
        <p:spPr>
          <a:xfrm>
            <a:off x="3283724" y="6177052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.2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9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C2690DE-3966-C241-815B-CE47B3537FB2}"/>
              </a:ext>
            </a:extLst>
          </p:cNvPr>
          <p:cNvSpPr/>
          <p:nvPr/>
        </p:nvSpPr>
        <p:spPr>
          <a:xfrm>
            <a:off x="6484468" y="6180757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 30.5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2	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BBDF622-C09E-1347-AD6F-27F50B5F4D29}"/>
              </a:ext>
            </a:extLst>
          </p:cNvPr>
          <p:cNvSpPr/>
          <p:nvPr/>
        </p:nvSpPr>
        <p:spPr>
          <a:xfrm>
            <a:off x="10671447" y="6177052"/>
            <a:ext cx="117211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34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0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FFFC289-F5C8-EA45-A350-1E669C5B3D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8692" y="557085"/>
            <a:ext cx="3657600" cy="280005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455CD34-63D9-0742-89BF-3726245FDC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4495" y="3399345"/>
            <a:ext cx="3657600" cy="280005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EE80A0A-9887-2444-A2F7-A960F7CD15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56917" y="3376998"/>
            <a:ext cx="3657600" cy="280005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22A6208-C134-8949-952E-CD16BA23DD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75932" y="407838"/>
            <a:ext cx="3657600" cy="280005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E899004-FAC9-1948-918B-4FBEB60D35A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46823" y="442387"/>
            <a:ext cx="3657600" cy="280005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B566F8A-0EDD-ED4A-A931-C0D300161B8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59530" y="3276991"/>
            <a:ext cx="3657600" cy="2800054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7641DE3D-C196-634B-A834-86C8400EB27C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31362961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C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1872460" y="109802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040587" y="100061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THNICIT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2A8A256-6801-1742-8AA5-CDF453F9D73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218" r="7500"/>
          <a:stretch/>
        </p:blipFill>
        <p:spPr>
          <a:xfrm>
            <a:off x="4216402" y="417579"/>
            <a:ext cx="4206240" cy="319505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5A8BFCF-D25C-9146-B0EE-47BCE212147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029"/>
          <a:stretch/>
        </p:blipFill>
        <p:spPr>
          <a:xfrm>
            <a:off x="8144633" y="253947"/>
            <a:ext cx="4023360" cy="338576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86DF4CC-AB8F-7E41-9031-224A66C2368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294" r="24028"/>
          <a:stretch/>
        </p:blipFill>
        <p:spPr>
          <a:xfrm>
            <a:off x="1380499" y="3382234"/>
            <a:ext cx="3291840" cy="366939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D1B7F10-4500-FE48-A9B0-9F6523321BA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1990"/>
          <a:stretch/>
        </p:blipFill>
        <p:spPr>
          <a:xfrm>
            <a:off x="4570930" y="3255507"/>
            <a:ext cx="3200400" cy="360249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849E92E-2B01-5745-BC44-445EE141B6F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1586"/>
          <a:stretch/>
        </p:blipFill>
        <p:spPr>
          <a:xfrm>
            <a:off x="8649397" y="3582289"/>
            <a:ext cx="3291840" cy="3213750"/>
          </a:xfrm>
          <a:prstGeom prst="rect">
            <a:avLst/>
          </a:prstGeom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id="{C9924915-DA48-824A-ACAF-1E06B499EFE9}"/>
              </a:ext>
            </a:extLst>
          </p:cNvPr>
          <p:cNvGrpSpPr/>
          <p:nvPr/>
        </p:nvGrpSpPr>
        <p:grpSpPr>
          <a:xfrm>
            <a:off x="1099341" y="215850"/>
            <a:ext cx="3383280" cy="3366439"/>
            <a:chOff x="1099341" y="215850"/>
            <a:chExt cx="3383280" cy="336643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17EC379-E16C-A846-A431-EF3B5EB6DA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26750" b="14035"/>
            <a:stretch/>
          </p:blipFill>
          <p:spPr>
            <a:xfrm>
              <a:off x="1099341" y="215850"/>
              <a:ext cx="3383280" cy="3039658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54625A7-F8FC-4345-B6D1-657C4815182D}"/>
                </a:ext>
              </a:extLst>
            </p:cNvPr>
            <p:cNvSpPr txBox="1"/>
            <p:nvPr/>
          </p:nvSpPr>
          <p:spPr>
            <a:xfrm>
              <a:off x="1872460" y="3259124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hite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7941394-3F2F-1349-ACA8-86ED0D009DBA}"/>
                </a:ext>
              </a:extLst>
            </p:cNvPr>
            <p:cNvSpPr txBox="1"/>
            <p:nvPr/>
          </p:nvSpPr>
          <p:spPr>
            <a:xfrm>
              <a:off x="2318959" y="3259124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sian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A18829F-5032-9C4C-ACBF-250BAD7CF035}"/>
                </a:ext>
              </a:extLst>
            </p:cNvPr>
            <p:cNvSpPr txBox="1"/>
            <p:nvPr/>
          </p:nvSpPr>
          <p:spPr>
            <a:xfrm>
              <a:off x="2663980" y="3182179"/>
              <a:ext cx="72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frican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merican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C50C296-C571-5C4D-BDE3-79FC1033F3A3}"/>
                </a:ext>
              </a:extLst>
            </p:cNvPr>
            <p:cNvSpPr txBox="1"/>
            <p:nvPr/>
          </p:nvSpPr>
          <p:spPr>
            <a:xfrm>
              <a:off x="3195926" y="3182179"/>
              <a:ext cx="724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merican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ndian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83C2537-9E0A-4D41-AA7B-164E4775A41A}"/>
                </a:ext>
              </a:extLst>
            </p:cNvPr>
            <p:cNvSpPr txBox="1"/>
            <p:nvPr/>
          </p:nvSpPr>
          <p:spPr>
            <a:xfrm>
              <a:off x="3810786" y="3259124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ther</a:t>
              </a:r>
            </a:p>
          </p:txBody>
        </p: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F570FEA4-C029-A34D-912A-2DE5611E869B}"/>
              </a:ext>
            </a:extLst>
          </p:cNvPr>
          <p:cNvSpPr/>
          <p:nvPr/>
        </p:nvSpPr>
        <p:spPr>
          <a:xfrm>
            <a:off x="3412955" y="3497055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35.6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01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76B4CD7-7226-944E-B564-DDEC3F92654E}"/>
              </a:ext>
            </a:extLst>
          </p:cNvPr>
          <p:cNvSpPr/>
          <p:nvPr/>
        </p:nvSpPr>
        <p:spPr>
          <a:xfrm>
            <a:off x="7124998" y="3429000"/>
            <a:ext cx="123623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59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0002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9D42705-C24C-5549-BFED-FA560E282DE0}"/>
              </a:ext>
            </a:extLst>
          </p:cNvPr>
          <p:cNvSpPr/>
          <p:nvPr/>
        </p:nvSpPr>
        <p:spPr>
          <a:xfrm>
            <a:off x="11081885" y="3424396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96.06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6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D20CA73-5EEF-D141-8E54-09056A33A886}"/>
              </a:ext>
            </a:extLst>
          </p:cNvPr>
          <p:cNvSpPr/>
          <p:nvPr/>
        </p:nvSpPr>
        <p:spPr>
          <a:xfrm>
            <a:off x="3722145" y="6619652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8.8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3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EA3A4622-2491-0149-AB85-815DFA47DB3A}"/>
              </a:ext>
            </a:extLst>
          </p:cNvPr>
          <p:cNvSpPr/>
          <p:nvPr/>
        </p:nvSpPr>
        <p:spPr>
          <a:xfrm>
            <a:off x="7355098" y="6627168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7.3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4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025D594B-8EB3-AD4F-B70B-D8316DD2A2B7}"/>
              </a:ext>
            </a:extLst>
          </p:cNvPr>
          <p:cNvSpPr/>
          <p:nvPr/>
        </p:nvSpPr>
        <p:spPr>
          <a:xfrm>
            <a:off x="11252357" y="6619652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35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EAA039F-F44B-844F-BC84-B8F9B2FA2E53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4935054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C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2266947" y="109802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295138" y="109802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1132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THNICITY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38A243A-613D-B34E-AD70-BF3116E3D0EC}"/>
              </a:ext>
            </a:extLst>
          </p:cNvPr>
          <p:cNvSpPr/>
          <p:nvPr/>
        </p:nvSpPr>
        <p:spPr>
          <a:xfrm>
            <a:off x="3283724" y="2954558"/>
            <a:ext cx="98296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6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sz="900" dirty="0"/>
              <a:t> 0.08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0941FC0-A98B-2847-BBC5-2562371A6F93}"/>
              </a:ext>
            </a:extLst>
          </p:cNvPr>
          <p:cNvSpPr/>
          <p:nvPr/>
        </p:nvSpPr>
        <p:spPr>
          <a:xfrm>
            <a:off x="6588351" y="2949844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 31.9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2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0E3F26B9-B9A1-C646-A8B6-AE9722954932}"/>
              </a:ext>
            </a:extLst>
          </p:cNvPr>
          <p:cNvSpPr/>
          <p:nvPr/>
        </p:nvSpPr>
        <p:spPr>
          <a:xfrm>
            <a:off x="10570751" y="2949844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02.4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2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4436634-1703-3044-B07D-B18C8883034B}"/>
              </a:ext>
            </a:extLst>
          </p:cNvPr>
          <p:cNvSpPr/>
          <p:nvPr/>
        </p:nvSpPr>
        <p:spPr>
          <a:xfrm>
            <a:off x="3283724" y="6103670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.8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17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C2690DE-3966-C241-815B-CE47B3537FB2}"/>
              </a:ext>
            </a:extLst>
          </p:cNvPr>
          <p:cNvSpPr/>
          <p:nvPr/>
        </p:nvSpPr>
        <p:spPr>
          <a:xfrm>
            <a:off x="6844029" y="6103670"/>
            <a:ext cx="11079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 4.43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48	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BBDF622-C09E-1347-AD6F-27F50B5F4D29}"/>
              </a:ext>
            </a:extLst>
          </p:cNvPr>
          <p:cNvSpPr/>
          <p:nvPr/>
        </p:nvSpPr>
        <p:spPr>
          <a:xfrm>
            <a:off x="10596695" y="6103670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52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4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2063ED9-675E-0A49-8A90-85CE0BCF66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08692" y="276576"/>
            <a:ext cx="3657600" cy="280005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F7091D1-3E56-D44C-B08D-16F2326C08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5058" y="276576"/>
            <a:ext cx="3657600" cy="280005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0248CBC-6467-E540-8293-BA8B7B6520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7408" y="460571"/>
            <a:ext cx="3657600" cy="280005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E951BE1-13B0-F84D-AB9E-D4789135AD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45058" y="3260625"/>
            <a:ext cx="3657600" cy="280005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A748467-FD3C-B240-ABE4-31995CA6A1C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91847" y="3304711"/>
            <a:ext cx="3657600" cy="280005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D37DFEE3-8CB9-774F-835B-64A5A65883A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7408" y="3335859"/>
            <a:ext cx="3657600" cy="2800054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14FDEEFE-4969-9D4E-9136-C4EEB1F3E5C6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8894371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954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2693043" y="60422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040587" y="100061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118494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NICAL </a:t>
            </a:r>
          </a:p>
          <a:p>
            <a:r>
              <a:rPr lang="en-US" dirty="0"/>
              <a:t>RESPONSE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E1FE6883-E270-7544-9354-87E10DD0E0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621" t="6852" r="29333" b="9445"/>
          <a:stretch/>
        </p:blipFill>
        <p:spPr>
          <a:xfrm>
            <a:off x="1594441" y="215027"/>
            <a:ext cx="3291840" cy="32934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98263A8-D3AA-654E-85E5-E172F245E83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72" t="10434" r="50000"/>
          <a:stretch/>
        </p:blipFill>
        <p:spPr>
          <a:xfrm>
            <a:off x="5307222" y="265179"/>
            <a:ext cx="2011680" cy="308383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3F76E07-E8FD-0F47-9DAE-4B0BB5CF9A4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5046"/>
          <a:stretch/>
        </p:blipFill>
        <p:spPr>
          <a:xfrm>
            <a:off x="4625438" y="3117223"/>
            <a:ext cx="3383280" cy="345554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AA7AFBA-B20C-E347-99D3-220ADAE7309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3850"/>
          <a:stretch/>
        </p:blipFill>
        <p:spPr>
          <a:xfrm>
            <a:off x="8072787" y="3225801"/>
            <a:ext cx="3657600" cy="325018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12636B3-DBD9-7848-8583-E3B7001D2AB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0872"/>
          <a:stretch/>
        </p:blipFill>
        <p:spPr>
          <a:xfrm>
            <a:off x="8030074" y="50310"/>
            <a:ext cx="3840480" cy="3298700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E0C5E5B4-CF06-854D-82D9-3D457CB6CDD4}"/>
              </a:ext>
            </a:extLst>
          </p:cNvPr>
          <p:cNvGrpSpPr/>
          <p:nvPr/>
        </p:nvGrpSpPr>
        <p:grpSpPr>
          <a:xfrm>
            <a:off x="1262041" y="3429000"/>
            <a:ext cx="3474720" cy="3318855"/>
            <a:chOff x="1260567" y="3013850"/>
            <a:chExt cx="3474720" cy="3318855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C508444-D8DC-FD43-830E-8B95076FA1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32988" b="28656"/>
            <a:stretch/>
          </p:blipFill>
          <p:spPr>
            <a:xfrm>
              <a:off x="1260567" y="3013850"/>
              <a:ext cx="3474720" cy="2831993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BD4DD5A-A51C-0248-AAA2-38960954BADC}"/>
                </a:ext>
              </a:extLst>
            </p:cNvPr>
            <p:cNvSpPr txBox="1"/>
            <p:nvPr/>
          </p:nvSpPr>
          <p:spPr>
            <a:xfrm>
              <a:off x="2082800" y="5937499"/>
              <a:ext cx="9332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sponde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904EDAC-9B35-3F49-9321-6BF839BBD4B9}"/>
                </a:ext>
              </a:extLst>
            </p:cNvPr>
            <p:cNvSpPr txBox="1"/>
            <p:nvPr/>
          </p:nvSpPr>
          <p:spPr>
            <a:xfrm>
              <a:off x="2939869" y="5871040"/>
              <a:ext cx="9332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on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sponder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9396C27-C308-2541-952F-05084BBD9386}"/>
                </a:ext>
              </a:extLst>
            </p:cNvPr>
            <p:cNvSpPr txBox="1"/>
            <p:nvPr/>
          </p:nvSpPr>
          <p:spPr>
            <a:xfrm>
              <a:off x="3942717" y="585836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A38A243A-613D-B34E-AD70-BF3116E3D0EC}"/>
              </a:ext>
            </a:extLst>
          </p:cNvPr>
          <p:cNvSpPr/>
          <p:nvPr/>
        </p:nvSpPr>
        <p:spPr>
          <a:xfrm>
            <a:off x="3234061" y="3168513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5.2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7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0941FC0-A98B-2847-BBC5-2562371A6F93}"/>
              </a:ext>
            </a:extLst>
          </p:cNvPr>
          <p:cNvSpPr/>
          <p:nvPr/>
        </p:nvSpPr>
        <p:spPr>
          <a:xfrm>
            <a:off x="6473858" y="3168513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6.5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1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0E3F26B9-B9A1-C646-A8B6-AE9722954932}"/>
              </a:ext>
            </a:extLst>
          </p:cNvPr>
          <p:cNvSpPr/>
          <p:nvPr/>
        </p:nvSpPr>
        <p:spPr>
          <a:xfrm>
            <a:off x="10643747" y="3129829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42.4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6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4436634-1703-3044-B07D-B18C8883034B}"/>
              </a:ext>
            </a:extLst>
          </p:cNvPr>
          <p:cNvSpPr/>
          <p:nvPr/>
        </p:nvSpPr>
        <p:spPr>
          <a:xfrm>
            <a:off x="3873281" y="6514232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0.79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7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C2690DE-3966-C241-815B-CE47B3537FB2}"/>
              </a:ext>
            </a:extLst>
          </p:cNvPr>
          <p:cNvSpPr/>
          <p:nvPr/>
        </p:nvSpPr>
        <p:spPr>
          <a:xfrm>
            <a:off x="6764904" y="6552294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3.33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6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BBDF622-C09E-1347-AD6F-27F50B5F4D29}"/>
              </a:ext>
            </a:extLst>
          </p:cNvPr>
          <p:cNvSpPr/>
          <p:nvPr/>
        </p:nvSpPr>
        <p:spPr>
          <a:xfrm>
            <a:off x="10485717" y="6472192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41.04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1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8A5AC6E-960F-5F4F-BC02-BE2D1099D5B4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9058466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954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DE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2304034" y="100060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490470" y="2840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040587" y="100061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118494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NICAL </a:t>
            </a:r>
          </a:p>
          <a:p>
            <a:r>
              <a:rPr lang="en-US" dirty="0"/>
              <a:t>RESPONSE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38A243A-613D-B34E-AD70-BF3116E3D0EC}"/>
              </a:ext>
            </a:extLst>
          </p:cNvPr>
          <p:cNvSpPr/>
          <p:nvPr/>
        </p:nvSpPr>
        <p:spPr>
          <a:xfrm>
            <a:off x="3254024" y="3015606"/>
            <a:ext cx="11592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 40.9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1.3E-9 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0941FC0-A98B-2847-BBC5-2562371A6F93}"/>
              </a:ext>
            </a:extLst>
          </p:cNvPr>
          <p:cNvSpPr/>
          <p:nvPr/>
        </p:nvSpPr>
        <p:spPr>
          <a:xfrm>
            <a:off x="6521247" y="2971183"/>
            <a:ext cx="109517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46.9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1.9E-8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0E3F26B9-B9A1-C646-A8B6-AE9722954932}"/>
              </a:ext>
            </a:extLst>
          </p:cNvPr>
          <p:cNvSpPr/>
          <p:nvPr/>
        </p:nvSpPr>
        <p:spPr>
          <a:xfrm>
            <a:off x="10695047" y="2971183"/>
            <a:ext cx="106311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87.2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1.7E-7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4436634-1703-3044-B07D-B18C8883034B}"/>
              </a:ext>
            </a:extLst>
          </p:cNvPr>
          <p:cNvSpPr/>
          <p:nvPr/>
        </p:nvSpPr>
        <p:spPr>
          <a:xfrm>
            <a:off x="3561801" y="6044183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6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C2690DE-3966-C241-815B-CE47B3537FB2}"/>
              </a:ext>
            </a:extLst>
          </p:cNvPr>
          <p:cNvSpPr/>
          <p:nvPr/>
        </p:nvSpPr>
        <p:spPr>
          <a:xfrm>
            <a:off x="6894659" y="6083689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4.2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7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BBDF622-C09E-1347-AD6F-27F50B5F4D29}"/>
              </a:ext>
            </a:extLst>
          </p:cNvPr>
          <p:cNvSpPr/>
          <p:nvPr/>
        </p:nvSpPr>
        <p:spPr>
          <a:xfrm>
            <a:off x="10962367" y="6097257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61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2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8F496F9-1F5E-AB4B-A86D-5D04EA32BF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2715" y="188668"/>
            <a:ext cx="3657600" cy="280005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EDFD486-5106-7D49-A8B2-E4957FA486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2832" y="272664"/>
            <a:ext cx="3657600" cy="2800054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F6822ED0-E3F8-F947-832E-1E162CB8FD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59446" y="268356"/>
            <a:ext cx="3657600" cy="2800054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2B3F0F79-8B30-104D-9991-29B52D50235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9462" y="3328125"/>
            <a:ext cx="3657600" cy="280005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9D32B3CE-4B22-6D44-874A-23AB2B29A1D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45058" y="3244129"/>
            <a:ext cx="3657600" cy="2800054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BD4EFC1-4E8A-464C-B45A-543462149B3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34400" y="3365025"/>
            <a:ext cx="3657600" cy="2800054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A9475470-3506-8741-84AD-43E07F4E4AC2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1889423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107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OH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2377440" y="61961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040587" y="100061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MOKING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39084CE-584E-4A42-B397-561654FB5A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3631"/>
          <a:stretch/>
        </p:blipFill>
        <p:spPr>
          <a:xfrm>
            <a:off x="1145061" y="417579"/>
            <a:ext cx="3291840" cy="329985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4F1FC36-44B2-2642-A534-C8AEF8CE03F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2355"/>
          <a:stretch/>
        </p:blipFill>
        <p:spPr>
          <a:xfrm>
            <a:off x="4588633" y="217338"/>
            <a:ext cx="3383280" cy="333577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2F12339-9B8B-A749-BA5F-C67112ED799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0164"/>
          <a:stretch/>
        </p:blipFill>
        <p:spPr>
          <a:xfrm>
            <a:off x="8240987" y="389056"/>
            <a:ext cx="3657600" cy="311682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7B52B7F-AA27-AB4E-8742-03872E64ECE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6056"/>
          <a:stretch/>
        </p:blipFill>
        <p:spPr>
          <a:xfrm>
            <a:off x="1145061" y="3314007"/>
            <a:ext cx="3383280" cy="350271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B046266-65B9-B746-9C3D-485632210CF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1221"/>
          <a:stretch/>
        </p:blipFill>
        <p:spPr>
          <a:xfrm>
            <a:off x="4616573" y="3136359"/>
            <a:ext cx="3474720" cy="337660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D0C22DE2-60C6-DA46-92EC-07D84E3CE4D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8037"/>
          <a:stretch/>
        </p:blipFill>
        <p:spPr>
          <a:xfrm>
            <a:off x="8179525" y="3314007"/>
            <a:ext cx="3931920" cy="3273112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32EF032A-476E-9D4D-BD2C-4AC4CA7A01F3}"/>
              </a:ext>
            </a:extLst>
          </p:cNvPr>
          <p:cNvSpPr/>
          <p:nvPr/>
        </p:nvSpPr>
        <p:spPr>
          <a:xfrm>
            <a:off x="7124998" y="3429000"/>
            <a:ext cx="97975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5.4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12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2CAE142-6A2B-0D4E-916B-11BEB3D221E0}"/>
              </a:ext>
            </a:extLst>
          </p:cNvPr>
          <p:cNvSpPr/>
          <p:nvPr/>
        </p:nvSpPr>
        <p:spPr>
          <a:xfrm>
            <a:off x="3167479" y="3390465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3.5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3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9354211-9A7B-B448-8291-66E6000C19FF}"/>
              </a:ext>
            </a:extLst>
          </p:cNvPr>
          <p:cNvSpPr/>
          <p:nvPr/>
        </p:nvSpPr>
        <p:spPr>
          <a:xfrm>
            <a:off x="3167479" y="6498441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2.6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5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329FA66-4CAC-EF49-BA81-1246CB193F26}"/>
              </a:ext>
            </a:extLst>
          </p:cNvPr>
          <p:cNvSpPr/>
          <p:nvPr/>
        </p:nvSpPr>
        <p:spPr>
          <a:xfrm>
            <a:off x="7004751" y="6471703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29.4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1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EB46D6D-D7A9-5A45-A423-B66321C2FC83}"/>
              </a:ext>
            </a:extLst>
          </p:cNvPr>
          <p:cNvSpPr/>
          <p:nvPr/>
        </p:nvSpPr>
        <p:spPr>
          <a:xfrm>
            <a:off x="10723813" y="3309736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43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5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21FD99C-432D-3041-ABE7-0FD5B4A6B8AA}"/>
              </a:ext>
            </a:extLst>
          </p:cNvPr>
          <p:cNvSpPr/>
          <p:nvPr/>
        </p:nvSpPr>
        <p:spPr>
          <a:xfrm>
            <a:off x="10802341" y="6529411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81.7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3DA023-6A2F-1A46-A4FB-294CDC4E2A90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0631146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4A454F-F671-D745-8773-3BCB1F742C1D}"/>
              </a:ext>
            </a:extLst>
          </p:cNvPr>
          <p:cNvSpPr txBox="1"/>
          <p:nvPr/>
        </p:nvSpPr>
        <p:spPr>
          <a:xfrm>
            <a:off x="202987" y="1123884"/>
            <a:ext cx="107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OH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54680C-037C-654D-8659-D033F98575CB}"/>
              </a:ext>
            </a:extLst>
          </p:cNvPr>
          <p:cNvSpPr txBox="1"/>
          <p:nvPr/>
        </p:nvSpPr>
        <p:spPr>
          <a:xfrm>
            <a:off x="2854801" y="63399"/>
            <a:ext cx="918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46D0791-0135-204E-A438-99606F537C8E}"/>
              </a:ext>
            </a:extLst>
          </p:cNvPr>
          <p:cNvSpPr txBox="1"/>
          <p:nvPr/>
        </p:nvSpPr>
        <p:spPr>
          <a:xfrm>
            <a:off x="8770888" y="61961"/>
            <a:ext cx="32676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 AND TI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8F03B8-71E4-D04F-BA73-D01BC0CE1E7E}"/>
              </a:ext>
            </a:extLst>
          </p:cNvPr>
          <p:cNvSpPr txBox="1"/>
          <p:nvPr/>
        </p:nvSpPr>
        <p:spPr>
          <a:xfrm>
            <a:off x="5521118" y="50699"/>
            <a:ext cx="2357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ACTOR BY TREATME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9234B-396D-B647-8F20-8D9D45AA4F3F}"/>
              </a:ext>
            </a:extLst>
          </p:cNvPr>
          <p:cNvSpPr txBox="1"/>
          <p:nvPr/>
        </p:nvSpPr>
        <p:spPr>
          <a:xfrm>
            <a:off x="202987" y="412753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MOKING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32EF032A-476E-9D4D-BD2C-4AC4CA7A01F3}"/>
              </a:ext>
            </a:extLst>
          </p:cNvPr>
          <p:cNvSpPr/>
          <p:nvPr/>
        </p:nvSpPr>
        <p:spPr>
          <a:xfrm>
            <a:off x="7151414" y="2866021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3.2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2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2CAE142-6A2B-0D4E-916B-11BEB3D221E0}"/>
              </a:ext>
            </a:extLst>
          </p:cNvPr>
          <p:cNvSpPr/>
          <p:nvPr/>
        </p:nvSpPr>
        <p:spPr>
          <a:xfrm>
            <a:off x="3493814" y="2870027"/>
            <a:ext cx="91563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6.8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8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9354211-9A7B-B448-8291-66E6000C19FF}"/>
              </a:ext>
            </a:extLst>
          </p:cNvPr>
          <p:cNvSpPr/>
          <p:nvPr/>
        </p:nvSpPr>
        <p:spPr>
          <a:xfrm>
            <a:off x="3493814" y="6354042"/>
            <a:ext cx="85151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.1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7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329FA66-4CAC-EF49-BA81-1246CB193F26}"/>
              </a:ext>
            </a:extLst>
          </p:cNvPr>
          <p:cNvSpPr/>
          <p:nvPr/>
        </p:nvSpPr>
        <p:spPr>
          <a:xfrm>
            <a:off x="7002871" y="6353556"/>
            <a:ext cx="8835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19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4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EB46D6D-D7A9-5A45-A423-B66321C2FC83}"/>
              </a:ext>
            </a:extLst>
          </p:cNvPr>
          <p:cNvSpPr/>
          <p:nvPr/>
        </p:nvSpPr>
        <p:spPr>
          <a:xfrm>
            <a:off x="10866461" y="2866021"/>
            <a:ext cx="10438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75.6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2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21FD99C-432D-3041-ABE7-0FD5B4A6B8AA}"/>
              </a:ext>
            </a:extLst>
          </p:cNvPr>
          <p:cNvSpPr/>
          <p:nvPr/>
        </p:nvSpPr>
        <p:spPr>
          <a:xfrm>
            <a:off x="10866461" y="6383025"/>
            <a:ext cx="117211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=96.6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0.00004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C2C0FDE-AFB4-0541-A794-02CFA3B138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98187" y="215849"/>
            <a:ext cx="3657600" cy="280005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DAB59D45-4E01-B74F-9550-9FF1FA5052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0286" y="3390465"/>
            <a:ext cx="3657600" cy="280005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A9D0F3B8-5A4E-9345-901E-603F04C746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40587" y="3309736"/>
            <a:ext cx="3657600" cy="2800054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B46D769-CB33-B940-84CF-CEAC8722EF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70888" y="3425152"/>
            <a:ext cx="3657600" cy="2800054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F7E80BC5-BB4E-4849-9AFE-8572FD4C11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37039" y="146917"/>
            <a:ext cx="3657600" cy="2800054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51B389D7-6089-1B42-91B3-C7143D74EF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14123" y="181383"/>
            <a:ext cx="3657600" cy="2800054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7CCE7564-3197-B841-899E-D42BC92F3442}"/>
              </a:ext>
            </a:extLst>
          </p:cNvPr>
          <p:cNvSpPr txBox="1"/>
          <p:nvPr/>
        </p:nvSpPr>
        <p:spPr>
          <a:xfrm>
            <a:off x="0" y="4286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350815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97</TotalTime>
  <Words>485</Words>
  <Application>Microsoft Macintosh PowerPoint</Application>
  <PresentationFormat>Widescreen</PresentationFormat>
  <Paragraphs>124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zcarate-Peril, M. Andrea</dc:creator>
  <cp:lastModifiedBy>Azcarate-Peril, M. Andrea</cp:lastModifiedBy>
  <cp:revision>25</cp:revision>
  <dcterms:created xsi:type="dcterms:W3CDTF">2020-09-29T15:40:56Z</dcterms:created>
  <dcterms:modified xsi:type="dcterms:W3CDTF">2021-06-22T18:22:40Z</dcterms:modified>
</cp:coreProperties>
</file>